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92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85" autoAdjust="0"/>
    <p:restoredTop sz="94660"/>
  </p:normalViewPr>
  <p:slideViewPr>
    <p:cSldViewPr snapToGrid="0">
      <p:cViewPr>
        <p:scale>
          <a:sx n="178" d="100"/>
          <a:sy n="178" d="100"/>
        </p:scale>
        <p:origin x="888" y="-50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057E124-7984-47DF-9DB3-96261744DEEC}" type="datetimeFigureOut">
              <a:rPr lang="en-IN" smtClean="0"/>
              <a:t>26-07-2025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A1D031-33C9-4BD1-86F3-2A3FA351121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449209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26-07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594093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26-07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905802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26-07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037305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26-07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86844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26-07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04833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26-07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126280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26-07-202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7724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26-07-202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973017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26-07-202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410046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26-07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504303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26-07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369531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3023C0-FC84-4236-83BA-364191644CDB}" type="datetimeFigureOut">
              <a:rPr lang="en-IN" smtClean="0"/>
              <a:t>26-07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713686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B1947FD-6FC6-467D-6C49-F2E83154A0DC}"/>
              </a:ext>
            </a:extLst>
          </p:cNvPr>
          <p:cNvSpPr txBox="1"/>
          <p:nvPr/>
        </p:nvSpPr>
        <p:spPr>
          <a:xfrm>
            <a:off x="588374" y="7300989"/>
            <a:ext cx="5880203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: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fluence of GYY(4137) and glutathione on </a:t>
            </a:r>
            <a:r>
              <a:rPr lang="en-US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r, epi,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s of tomato. The top panel (</a:t>
            </a:r>
            <a:r>
              <a:rPr lang="en-US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shows GYY(4137) stimulates root elongation of dark-grown seedlings of </a:t>
            </a:r>
            <a:r>
              <a:rPr lang="en-US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, while its effect on </a:t>
            </a:r>
            <a:r>
              <a:rPr lang="en-US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r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 ethylene receptor mutant, and </a:t>
            </a:r>
            <a:r>
              <a:rPr lang="en-US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i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 ethylene overproducer mutant, is only mild.. The bottom panel (</a:t>
            </a:r>
            <a:r>
              <a:rPr lang="en-US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shows that glutathione suppresses root elongation of dark-grown seedlings in all three mutants, including that of the AC control. The </a:t>
            </a:r>
            <a:r>
              <a:rPr lang="en-US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r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i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s were in the AC background. </a:t>
            </a:r>
            <a:endParaRPr lang="en-US" alt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FDF98817-4DAD-F55C-AC07-375D2015EBD1}"/>
              </a:ext>
            </a:extLst>
          </p:cNvPr>
          <p:cNvGrpSpPr/>
          <p:nvPr/>
        </p:nvGrpSpPr>
        <p:grpSpPr>
          <a:xfrm>
            <a:off x="1003480" y="1797828"/>
            <a:ext cx="4888788" cy="5331006"/>
            <a:chOff x="1003480" y="347851"/>
            <a:chExt cx="4888788" cy="5331006"/>
          </a:xfrm>
        </p:grpSpPr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9D461E54-6A67-12EE-3172-11D46ABDF626}"/>
                </a:ext>
              </a:extLst>
            </p:cNvPr>
            <p:cNvGrpSpPr/>
            <p:nvPr/>
          </p:nvGrpSpPr>
          <p:grpSpPr>
            <a:xfrm>
              <a:off x="1003480" y="3460463"/>
              <a:ext cx="4888788" cy="2218394"/>
              <a:chOff x="440858" y="2946508"/>
              <a:chExt cx="4888788" cy="2218394"/>
            </a:xfrm>
          </p:grpSpPr>
          <p:grpSp>
            <p:nvGrpSpPr>
              <p:cNvPr id="16" name="Group 15">
                <a:extLst>
                  <a:ext uri="{FF2B5EF4-FFF2-40B4-BE49-F238E27FC236}">
                    <a16:creationId xmlns:a16="http://schemas.microsoft.com/office/drawing/2014/main" id="{D1A651A7-D504-2AD0-A5C5-F6E8651AF51D}"/>
                  </a:ext>
                </a:extLst>
              </p:cNvPr>
              <p:cNvGrpSpPr/>
              <p:nvPr/>
            </p:nvGrpSpPr>
            <p:grpSpPr>
              <a:xfrm>
                <a:off x="440858" y="2946508"/>
                <a:ext cx="4888788" cy="1956784"/>
                <a:chOff x="440858" y="2946508"/>
                <a:chExt cx="4888788" cy="1956784"/>
              </a:xfrm>
            </p:grpSpPr>
            <p:grpSp>
              <p:nvGrpSpPr>
                <p:cNvPr id="12" name="Group 11">
                  <a:extLst>
                    <a:ext uri="{FF2B5EF4-FFF2-40B4-BE49-F238E27FC236}">
                      <a16:creationId xmlns:a16="http://schemas.microsoft.com/office/drawing/2014/main" id="{0B34F236-5CAC-73CA-C8F4-E6EF67164473}"/>
                    </a:ext>
                  </a:extLst>
                </p:cNvPr>
                <p:cNvGrpSpPr/>
                <p:nvPr/>
              </p:nvGrpSpPr>
              <p:grpSpPr>
                <a:xfrm>
                  <a:off x="515983" y="2946508"/>
                  <a:ext cx="4813663" cy="1883855"/>
                  <a:chOff x="515983" y="2946508"/>
                  <a:chExt cx="4813663" cy="1883855"/>
                </a:xfrm>
              </p:grpSpPr>
              <p:pic>
                <p:nvPicPr>
                  <p:cNvPr id="9" name="Picture 8">
                    <a:extLst>
                      <a:ext uri="{FF2B5EF4-FFF2-40B4-BE49-F238E27FC236}">
                        <a16:creationId xmlns:a16="http://schemas.microsoft.com/office/drawing/2014/main" id="{9C5ECE43-053A-C2A1-4D91-661EF06877C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15983" y="2946508"/>
                    <a:ext cx="1786414" cy="1883855"/>
                  </a:xfrm>
                  <a:prstGeom prst="rect">
                    <a:avLst/>
                  </a:prstGeom>
                </p:spPr>
              </p:pic>
              <p:pic>
                <p:nvPicPr>
                  <p:cNvPr id="11" name="Picture 10">
                    <a:extLst>
                      <a:ext uri="{FF2B5EF4-FFF2-40B4-BE49-F238E27FC236}">
                        <a16:creationId xmlns:a16="http://schemas.microsoft.com/office/drawing/2014/main" id="{7286E703-FE7F-240A-BFCE-064A634A961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r="20058"/>
                  <a:stretch>
                    <a:fillRect/>
                  </a:stretch>
                </p:blipFill>
                <p:spPr>
                  <a:xfrm>
                    <a:off x="2439956" y="2946508"/>
                    <a:ext cx="2889690" cy="1866519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13" name="TextBox 2">
                  <a:extLst>
                    <a:ext uri="{FF2B5EF4-FFF2-40B4-BE49-F238E27FC236}">
                      <a16:creationId xmlns:a16="http://schemas.microsoft.com/office/drawing/2014/main" id="{56BF5BB3-810D-2DC6-BE43-8EF17D15047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40858" y="4595515"/>
                  <a:ext cx="1937704" cy="3077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4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C      </a:t>
                  </a:r>
                  <a:r>
                    <a:rPr lang="en-US" altLang="en-US" sz="1400" b="1" i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Rs</a:t>
                  </a:r>
                  <a:r>
                    <a:rPr lang="en-US" altLang="en-US" sz="14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    </a:t>
                  </a:r>
                  <a:r>
                    <a:rPr lang="en-US" altLang="en-US" sz="1400" b="1" i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Nr</a:t>
                  </a:r>
                  <a:r>
                    <a:rPr lang="en-US" altLang="en-US" sz="14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    </a:t>
                  </a:r>
                  <a:r>
                    <a:rPr lang="en-US" altLang="en-US" sz="1400" b="1" i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pi</a:t>
                  </a:r>
                  <a:endParaRPr lang="en-US" altLang="en-US" sz="14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" name="TextBox 2">
                  <a:extLst>
                    <a:ext uri="{FF2B5EF4-FFF2-40B4-BE49-F238E27FC236}">
                      <a16:creationId xmlns:a16="http://schemas.microsoft.com/office/drawing/2014/main" id="{A0742D44-102E-1FD7-AD8B-2FE19790BB7D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2646450" y="4584294"/>
                  <a:ext cx="2683196" cy="3077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4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C         </a:t>
                  </a:r>
                  <a:r>
                    <a:rPr lang="en-US" altLang="en-US" sz="1400" b="1" i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Rs</a:t>
                  </a:r>
                  <a:r>
                    <a:rPr lang="en-US" altLang="en-US" sz="14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              </a:t>
                  </a:r>
                  <a:r>
                    <a:rPr lang="en-US" altLang="en-US" sz="1400" b="1" i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Nr</a:t>
                  </a:r>
                  <a:r>
                    <a:rPr lang="en-US" altLang="en-US" sz="14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    </a:t>
                  </a:r>
                  <a:r>
                    <a:rPr lang="en-US" altLang="en-US" sz="1400" b="1" i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pi</a:t>
                  </a:r>
                  <a:endParaRPr lang="en-US" altLang="en-US" sz="14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7" name="TextBox 2">
                <a:extLst>
                  <a:ext uri="{FF2B5EF4-FFF2-40B4-BE49-F238E27FC236}">
                    <a16:creationId xmlns:a16="http://schemas.microsoft.com/office/drawing/2014/main" id="{5F42A29B-4652-1799-3715-7CDC1F4A96A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02252" y="4857125"/>
                <a:ext cx="180014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</a:p>
            </p:txBody>
          </p:sp>
          <p:sp>
            <p:nvSpPr>
              <p:cNvPr id="18" name="TextBox 2">
                <a:extLst>
                  <a:ext uri="{FF2B5EF4-FFF2-40B4-BE49-F238E27FC236}">
                    <a16:creationId xmlns:a16="http://schemas.microsoft.com/office/drawing/2014/main" id="{3DEFF129-DAC0-20AE-E1A5-15807E0553B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984728" y="4857125"/>
                <a:ext cx="1937704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lutathione (1.5 mM)</a:t>
                </a:r>
              </a:p>
            </p:txBody>
          </p: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ADFDC7B8-6CF2-4307-3B00-3601424BB46B}"/>
                </a:ext>
              </a:extLst>
            </p:cNvPr>
            <p:cNvGrpSpPr/>
            <p:nvPr/>
          </p:nvGrpSpPr>
          <p:grpSpPr>
            <a:xfrm>
              <a:off x="1003480" y="347851"/>
              <a:ext cx="4832537" cy="2940457"/>
              <a:chOff x="1003480" y="347851"/>
              <a:chExt cx="4832537" cy="2940457"/>
            </a:xfrm>
          </p:grpSpPr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E54CC3C7-76F8-44B6-DE6F-A451EB37FC70}"/>
                  </a:ext>
                </a:extLst>
              </p:cNvPr>
              <p:cNvGrpSpPr/>
              <p:nvPr/>
            </p:nvGrpSpPr>
            <p:grpSpPr>
              <a:xfrm>
                <a:off x="1003480" y="347851"/>
                <a:ext cx="4832537" cy="2940457"/>
                <a:chOff x="182202" y="5295455"/>
                <a:chExt cx="4832537" cy="2940457"/>
              </a:xfrm>
            </p:grpSpPr>
            <p:pic>
              <p:nvPicPr>
                <p:cNvPr id="3" name="Picture 1" descr="wt rs nr epi contrl wt rs nr epi gyy200um wt rs nr epi gyy 100um.JPG">
                  <a:extLst>
                    <a:ext uri="{FF2B5EF4-FFF2-40B4-BE49-F238E27FC236}">
                      <a16:creationId xmlns:a16="http://schemas.microsoft.com/office/drawing/2014/main" id="{00134F9D-36E9-0324-4B5E-07E20BC88F8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499" t="15556" r="32164" b="34444"/>
                <a:stretch>
                  <a:fillRect/>
                </a:stretch>
              </p:blipFill>
              <p:spPr bwMode="auto">
                <a:xfrm>
                  <a:off x="182202" y="5295455"/>
                  <a:ext cx="4776287" cy="257773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4" name="TextBox 2">
                  <a:extLst>
                    <a:ext uri="{FF2B5EF4-FFF2-40B4-BE49-F238E27FC236}">
                      <a16:creationId xmlns:a16="http://schemas.microsoft.com/office/drawing/2014/main" id="{C396F3D7-3ED3-055F-EE1C-7D1695DCFA19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257326" y="7928135"/>
                  <a:ext cx="4757413" cy="3077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algn="ctr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YY (0.2 mM)</a:t>
                  </a:r>
                  <a:r>
                    <a:rPr lang="en-US" altLang="en-US" sz="14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 </a:t>
                  </a:r>
                </a:p>
              </p:txBody>
            </p:sp>
          </p:grpSp>
          <p:sp>
            <p:nvSpPr>
              <p:cNvPr id="6" name="Rectangle 5">
                <a:extLst>
                  <a:ext uri="{FF2B5EF4-FFF2-40B4-BE49-F238E27FC236}">
                    <a16:creationId xmlns:a16="http://schemas.microsoft.com/office/drawing/2014/main" id="{F8A93179-4E5F-60F3-EFC5-BEC9CF64F8C2}"/>
                  </a:ext>
                </a:extLst>
              </p:cNvPr>
              <p:cNvSpPr/>
              <p:nvPr/>
            </p:nvSpPr>
            <p:spPr>
              <a:xfrm>
                <a:off x="1507079" y="455013"/>
                <a:ext cx="3731342" cy="2207551"/>
              </a:xfrm>
              <a:prstGeom prst="rect">
                <a:avLst/>
              </a:prstGeom>
              <a:noFill/>
              <a:ln w="22225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8" name="TextBox 2">
                <a:extLst>
                  <a:ext uri="{FF2B5EF4-FFF2-40B4-BE49-F238E27FC236}">
                    <a16:creationId xmlns:a16="http://schemas.microsoft.com/office/drawing/2014/main" id="{C847DB4F-BD75-4612-DA6E-E7384E68B8B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165756" y="2628656"/>
                <a:ext cx="2683196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4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C        </a:t>
                </a:r>
                <a:r>
                  <a:rPr lang="en-US" altLang="en-US" sz="14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s</a:t>
                </a:r>
                <a:r>
                  <a:rPr lang="en-US" altLang="en-US" sz="14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      </a:t>
                </a:r>
                <a:r>
                  <a:rPr lang="en-US" altLang="en-US" sz="14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r</a:t>
                </a:r>
                <a:r>
                  <a:rPr lang="en-US" altLang="en-US" sz="14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    </a:t>
                </a:r>
                <a:r>
                  <a:rPr lang="en-US" altLang="en-US" sz="14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pi</a:t>
                </a:r>
                <a:endParaRPr lang="en-US" altLang="en-US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TextBox 2">
                <a:extLst>
                  <a:ext uri="{FF2B5EF4-FFF2-40B4-BE49-F238E27FC236}">
                    <a16:creationId xmlns:a16="http://schemas.microsoft.com/office/drawing/2014/main" id="{11554A44-D24A-CF54-8CC2-6F6EB0FBE1B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845508" y="2628656"/>
                <a:ext cx="1937704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4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C      </a:t>
                </a:r>
                <a:r>
                  <a:rPr lang="en-US" altLang="en-US" sz="14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s</a:t>
                </a:r>
                <a:r>
                  <a:rPr lang="en-US" altLang="en-US" sz="14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  </a:t>
                </a:r>
                <a:r>
                  <a:rPr lang="en-US" altLang="en-US" sz="14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r</a:t>
                </a:r>
                <a:r>
                  <a:rPr lang="en-US" altLang="en-US" sz="14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  </a:t>
                </a:r>
                <a:r>
                  <a:rPr lang="en-US" altLang="en-US" sz="14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pi</a:t>
                </a:r>
                <a:endParaRPr lang="en-US" altLang="en-US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9116E23C-73F6-2892-3327-520C70FA8972}"/>
              </a:ext>
            </a:extLst>
          </p:cNvPr>
          <p:cNvSpPr txBox="1"/>
          <p:nvPr/>
        </p:nvSpPr>
        <p:spPr>
          <a:xfrm>
            <a:off x="990067" y="148235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I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BB9A086-A9CB-8754-0033-AE4B22DA7FFE}"/>
              </a:ext>
            </a:extLst>
          </p:cNvPr>
          <p:cNvSpPr txBox="1"/>
          <p:nvPr/>
        </p:nvSpPr>
        <p:spPr>
          <a:xfrm>
            <a:off x="990067" y="444135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32593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06</TotalTime>
  <Words>133</Words>
  <Application>Microsoft Office PowerPoint</Application>
  <PresentationFormat>A4 Paper (210x297 mm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ameshwar Sharma</dc:creator>
  <cp:lastModifiedBy>Rameshwar Sharma</cp:lastModifiedBy>
  <cp:revision>17</cp:revision>
  <dcterms:created xsi:type="dcterms:W3CDTF">2025-06-16T09:20:07Z</dcterms:created>
  <dcterms:modified xsi:type="dcterms:W3CDTF">2025-07-26T07:03:11Z</dcterms:modified>
</cp:coreProperties>
</file>